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343" r:id="rId2"/>
    <p:sldId id="345" r:id="rId3"/>
    <p:sldId id="348" r:id="rId4"/>
    <p:sldId id="351" r:id="rId5"/>
    <p:sldId id="35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FF40FF"/>
    <a:srgbClr val="FFD579"/>
    <a:srgbClr val="FFA200"/>
    <a:srgbClr val="FFFA00"/>
    <a:srgbClr val="FFAA4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633"/>
    <p:restoredTop sz="96327"/>
  </p:normalViewPr>
  <p:slideViewPr>
    <p:cSldViewPr snapToGrid="0">
      <p:cViewPr>
        <p:scale>
          <a:sx n="75" d="100"/>
          <a:sy n="75" d="100"/>
        </p:scale>
        <p:origin x="1315" y="29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63C91C8-C664-2249-98DA-31D09714CAAA}" type="datetimeFigureOut">
              <a:rPr lang="en-US" smtClean="0"/>
              <a:t>7/9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43EB90-A352-B64D-BDF3-454FEFFACC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48399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4848FE-84E2-CF32-11C8-C7A68751A0B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DD32596-3010-762E-CDE9-4184E0AAC84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8435A9-6E30-95F4-0331-10AF63FDDE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51EDB-CEAF-BA4D-9E95-ED473C757ABE}" type="datetimeFigureOut">
              <a:rPr lang="en-US" smtClean="0"/>
              <a:t>7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B9645B-1D6E-C9E5-4D08-B93DFD8730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33F7F7-796B-0F89-A309-478E6957E6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368A-2DD1-A64D-BF48-F132430C9C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01970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D440B9-560B-0826-F533-7582E00B1A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39560FB-F56B-5902-EA2E-65814E0FB5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17137F-BAF8-C9DA-AF4E-375053466D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51EDB-CEAF-BA4D-9E95-ED473C757ABE}" type="datetimeFigureOut">
              <a:rPr lang="en-US" smtClean="0"/>
              <a:t>7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D19092-3D0B-91C0-1C14-B1718A82C1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76825C-5792-8D0C-B9BD-EAF8EAA5F1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368A-2DD1-A64D-BF48-F132430C9C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57286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FDB6099-83D7-5A85-2D52-8E8CB7F959C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C51F2F9-831D-251C-138A-B23B26904D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106F3B-9827-B526-052F-74D5EA4281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51EDB-CEAF-BA4D-9E95-ED473C757ABE}" type="datetimeFigureOut">
              <a:rPr lang="en-US" smtClean="0"/>
              <a:t>7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7AA520-66B6-4343-59EF-C85C02157A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7AB370-100D-976E-F399-230EF7DF0A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368A-2DD1-A64D-BF48-F132430C9C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6304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B092DA-16E3-676C-7EBE-2898BA2B07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59B0338-77B3-213E-832E-0CF80768AD7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78F981-52B8-2D9A-2F61-3DFDC87C3D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51EDB-CEAF-BA4D-9E95-ED473C757ABE}" type="datetimeFigureOut">
              <a:rPr lang="en-US" smtClean="0"/>
              <a:t>7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A1E9D1-556E-C170-33FB-BF232F3D1E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3B64EB-60ED-7D04-0869-4F45181721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368A-2DD1-A64D-BF48-F132430C9C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45515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C825B8-E197-B91C-2B51-BB6BD70098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61EE9A3-662E-9A12-D4CE-D6C19D24EF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5BE1E6-6B64-2188-B61C-F7B12C2DA0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51EDB-CEAF-BA4D-9E95-ED473C757ABE}" type="datetimeFigureOut">
              <a:rPr lang="en-US" smtClean="0"/>
              <a:t>7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67459D-F78E-267C-42EF-B299A814DF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676D47-239E-7CA2-8FC1-EB21123E8F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368A-2DD1-A64D-BF48-F132430C9C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4906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4EFDB8-A71A-1DD7-BB89-31A22AD622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F56F8E-95B0-EDE8-2156-D7493CA80BC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464DD8D-FDC5-F6DC-03BF-25FB52EE2C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A619DF-1404-120D-9E08-B8E85754B4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51EDB-CEAF-BA4D-9E95-ED473C757ABE}" type="datetimeFigureOut">
              <a:rPr lang="en-US" smtClean="0"/>
              <a:t>7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39E8C1C-FB1A-2861-7C04-DF9761B95D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C109A1-858F-D613-EEED-B3381A9AB8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368A-2DD1-A64D-BF48-F132430C9C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3795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A0136E-ECBB-B542-D40D-A5842ED1B5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A39C696-3A55-94ED-0D34-1BEF74BCED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86D488F-1032-E598-0CC5-2D9A539D65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E29A942-AA3F-6AB5-C200-C83D4F4B398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16FABC3-BC22-A2D8-7FCB-8470555D109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B4AA04D-88E0-085D-02E9-ACA071F791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51EDB-CEAF-BA4D-9E95-ED473C757ABE}" type="datetimeFigureOut">
              <a:rPr lang="en-US" smtClean="0"/>
              <a:t>7/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C6BE7B4-87A8-3866-9C2C-77849F62B6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9FEC7F3-6342-4A33-D724-D47F9CFE78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368A-2DD1-A64D-BF48-F132430C9C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31284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7B57E9-345E-FBB2-368D-173E4394D5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68F8CC0-203F-8CDF-CBC4-EAEDA17926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51EDB-CEAF-BA4D-9E95-ED473C757ABE}" type="datetimeFigureOut">
              <a:rPr lang="en-US" smtClean="0"/>
              <a:t>7/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CB1029D-5699-9356-5C10-4795EDDD67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E6E4FC0-AA75-86EC-E3D7-656BB82B64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368A-2DD1-A64D-BF48-F132430C9C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1523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4EBA57C-A29A-13E0-F1EF-BC7D81D04A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51EDB-CEAF-BA4D-9E95-ED473C757ABE}" type="datetimeFigureOut">
              <a:rPr lang="en-US" smtClean="0"/>
              <a:t>7/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E01AFCA-9367-DC2C-29D3-783AA93EED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29A9168-B07E-D041-7CC2-FB80E0FADF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368A-2DD1-A64D-BF48-F132430C9C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23765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013F3F-17B7-DE59-7105-12F53D47F5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66E573E-1C2F-4389-9888-225BE3BF74F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7BB7DCA-6032-5483-8339-7E739003F3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5280793-55E7-2F1A-03D1-BA7C3A0391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51EDB-CEAF-BA4D-9E95-ED473C757ABE}" type="datetimeFigureOut">
              <a:rPr lang="en-US" smtClean="0"/>
              <a:t>7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E2CDA00-E63F-806F-71D2-B91AAC3917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889F505-50D1-E67A-809F-8C66FF28BB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368A-2DD1-A64D-BF48-F132430C9C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02087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8F362D-C3DE-2EB1-5E9F-99D44BB186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5982795-C3FE-A1E2-C91E-F970ACDB8E9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753B19A-7276-5FB2-CDCD-CC5C08D3B7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A91CDEB-9E47-DBE6-4571-8F8981B98E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51EDB-CEAF-BA4D-9E95-ED473C757ABE}" type="datetimeFigureOut">
              <a:rPr lang="en-US" smtClean="0"/>
              <a:t>7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807E8D-B30D-8A5C-F657-88CA98E8C1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49C1DE-152A-955F-766C-D267E58DC4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368A-2DD1-A64D-BF48-F132430C9C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35938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B271D24-5992-561A-66B4-E219214C7F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BFE116-3243-88B5-805E-D9376CA536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A65003-2790-A038-1EB2-BC800901C4D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C51EDB-CEAF-BA4D-9E95-ED473C757ABE}" type="datetimeFigureOut">
              <a:rPr lang="en-US" smtClean="0"/>
              <a:t>7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B29F0D-C1D9-E479-A466-4B3AC11FC7F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32448F-F662-66DA-EEC1-67C4F0F2CC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24368A-2DD1-A64D-BF48-F132430C9C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45426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 descr="A graph showing the pressure&#10;&#10;Description automatically generated">
            <a:extLst>
              <a:ext uri="{FF2B5EF4-FFF2-40B4-BE49-F238E27FC236}">
                <a16:creationId xmlns:a16="http://schemas.microsoft.com/office/drawing/2014/main" id="{376547B4-4436-F6BC-F897-22E032857E3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6000" y="1415123"/>
            <a:ext cx="5760618" cy="4320000"/>
          </a:xfrm>
          <a:prstGeom prst="rect">
            <a:avLst/>
          </a:prstGeom>
        </p:spPr>
      </p:pic>
      <p:pic>
        <p:nvPicPr>
          <p:cNvPr id="11" name="Picture 10" descr="A graph of a pressure&#10;&#10;Description automatically generated with medium confidence">
            <a:extLst>
              <a:ext uri="{FF2B5EF4-FFF2-40B4-BE49-F238E27FC236}">
                <a16:creationId xmlns:a16="http://schemas.microsoft.com/office/drawing/2014/main" id="{A09995B3-1D8C-B303-D0AD-494012D987C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5382" y="1415123"/>
            <a:ext cx="5760618" cy="43200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2894626-D982-01DD-73C7-5AC8CB964D04}"/>
              </a:ext>
            </a:extLst>
          </p:cNvPr>
          <p:cNvSpPr txBox="1"/>
          <p:nvPr/>
        </p:nvSpPr>
        <p:spPr>
          <a:xfrm>
            <a:off x="2142317" y="3822106"/>
            <a:ext cx="20762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1800" dirty="0">
                <a:solidFill>
                  <a:srgbClr val="0432FF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800" dirty="0">
                <a:solidFill>
                  <a:srgbClr val="0432FF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−</a:t>
            </a:r>
            <a:r>
              <a:rPr lang="en-US" dirty="0">
                <a:solidFill>
                  <a:srgbClr val="0432FF"/>
                </a:solidFill>
              </a:rPr>
              <a:t>0.018 MHz/mmHg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148AE6D-76D2-63BB-E571-CECB3B2D4D2B}"/>
              </a:ext>
            </a:extLst>
          </p:cNvPr>
          <p:cNvSpPr txBox="1"/>
          <p:nvPr/>
        </p:nvSpPr>
        <p:spPr>
          <a:xfrm>
            <a:off x="2145820" y="4639850"/>
            <a:ext cx="21291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1800" dirty="0">
                <a:solidFill>
                  <a:srgbClr val="FF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800" dirty="0">
                <a:solidFill>
                  <a:srgbClr val="FF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−</a:t>
            </a:r>
            <a:r>
              <a:rPr lang="en-US" dirty="0">
                <a:solidFill>
                  <a:srgbClr val="FF0000"/>
                </a:solidFill>
              </a:rPr>
              <a:t>0.043 MHz/mmHg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A46FB81-80DD-14EE-EDA2-D927C4C847E8}"/>
              </a:ext>
            </a:extLst>
          </p:cNvPr>
          <p:cNvSpPr txBox="1"/>
          <p:nvPr/>
        </p:nvSpPr>
        <p:spPr>
          <a:xfrm>
            <a:off x="2182393" y="2565821"/>
            <a:ext cx="20233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>
                <a:solidFill>
                  <a:srgbClr val="FF40FF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−</a:t>
            </a:r>
            <a:r>
              <a:rPr lang="en-US" dirty="0">
                <a:solidFill>
                  <a:srgbClr val="FF40FF"/>
                </a:solidFill>
              </a:rPr>
              <a:t>0.089MHz/mmHg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EE4DA31-AA10-1356-CB9B-949E000277B4}"/>
              </a:ext>
            </a:extLst>
          </p:cNvPr>
          <p:cNvSpPr txBox="1"/>
          <p:nvPr/>
        </p:nvSpPr>
        <p:spPr>
          <a:xfrm>
            <a:off x="8472007" y="3575123"/>
            <a:ext cx="20762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>
                <a:solidFill>
                  <a:srgbClr val="FF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−</a:t>
            </a:r>
            <a:r>
              <a:rPr lang="en-US">
                <a:solidFill>
                  <a:srgbClr val="FF0000"/>
                </a:solidFill>
              </a:rPr>
              <a:t>0.031 </a:t>
            </a:r>
            <a:r>
              <a:rPr lang="en-US" dirty="0">
                <a:solidFill>
                  <a:srgbClr val="FF0000"/>
                </a:solidFill>
              </a:rPr>
              <a:t>MHz/mmHg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B4B839A-9D6F-3D94-83D2-D54DA81BBA9B}"/>
              </a:ext>
            </a:extLst>
          </p:cNvPr>
          <p:cNvSpPr txBox="1"/>
          <p:nvPr/>
        </p:nvSpPr>
        <p:spPr>
          <a:xfrm>
            <a:off x="335382" y="1230457"/>
            <a:ext cx="4363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a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7BE41D4-D673-2432-A300-720AF4EFDCBF}"/>
              </a:ext>
            </a:extLst>
          </p:cNvPr>
          <p:cNvSpPr txBox="1"/>
          <p:nvPr/>
        </p:nvSpPr>
        <p:spPr>
          <a:xfrm>
            <a:off x="6084780" y="1230457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b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F7E965B-17C1-80E8-20F9-1F0C9CA97EDF}"/>
              </a:ext>
            </a:extLst>
          </p:cNvPr>
          <p:cNvSpPr txBox="1"/>
          <p:nvPr/>
        </p:nvSpPr>
        <p:spPr>
          <a:xfrm>
            <a:off x="0" y="0"/>
            <a:ext cx="609946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/>
              <a:t>SI Figure S1</a:t>
            </a:r>
          </a:p>
        </p:txBody>
      </p:sp>
    </p:spTree>
    <p:extLst>
      <p:ext uri="{BB962C8B-B14F-4D97-AF65-F5344CB8AC3E}">
        <p14:creationId xmlns:p14="http://schemas.microsoft.com/office/powerpoint/2010/main" val="28537524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4" descr="A plastic container with a small white square container with blue rocks inside&#10;&#10;Description automatically generated">
            <a:extLst>
              <a:ext uri="{FF2B5EF4-FFF2-40B4-BE49-F238E27FC236}">
                <a16:creationId xmlns:a16="http://schemas.microsoft.com/office/drawing/2014/main" id="{5C478310-3333-EDD1-1CCE-A84AC510CB6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 rot="5400000">
            <a:off x="744718" y="2011919"/>
            <a:ext cx="4352925" cy="3264693"/>
          </a:xfrm>
        </p:spPr>
      </p:pic>
      <p:pic>
        <p:nvPicPr>
          <p:cNvPr id="3" name="Picture 2" descr="A white background with black dots&#10;&#10;Description automatically generated">
            <a:extLst>
              <a:ext uri="{FF2B5EF4-FFF2-40B4-BE49-F238E27FC236}">
                <a16:creationId xmlns:a16="http://schemas.microsoft.com/office/drawing/2014/main" id="{03C2756D-8EB5-6DC0-BE94-778C2FBC3CC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04161" y="1124265"/>
            <a:ext cx="6720724" cy="50400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BA72677-9017-1AB7-8710-8A05269380E2}"/>
              </a:ext>
            </a:extLst>
          </p:cNvPr>
          <p:cNvSpPr txBox="1"/>
          <p:nvPr/>
        </p:nvSpPr>
        <p:spPr>
          <a:xfrm>
            <a:off x="0" y="0"/>
            <a:ext cx="609946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/>
              <a:t>SI Figure S2</a:t>
            </a:r>
          </a:p>
        </p:txBody>
      </p:sp>
    </p:spTree>
    <p:extLst>
      <p:ext uri="{BB962C8B-B14F-4D97-AF65-F5344CB8AC3E}">
        <p14:creationId xmlns:p14="http://schemas.microsoft.com/office/powerpoint/2010/main" val="24375096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white background with black dots&#10;&#10;Description automatically generated">
            <a:extLst>
              <a:ext uri="{FF2B5EF4-FFF2-40B4-BE49-F238E27FC236}">
                <a16:creationId xmlns:a16="http://schemas.microsoft.com/office/drawing/2014/main" id="{68853504-9CE1-35EB-3839-0406AD91C97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5382" y="1269000"/>
            <a:ext cx="5760618" cy="4320000"/>
          </a:xfrm>
          <a:prstGeom prst="rect">
            <a:avLst/>
          </a:prstGeom>
        </p:spPr>
      </p:pic>
      <p:pic>
        <p:nvPicPr>
          <p:cNvPr id="5" name="Picture 4" descr="A white background with black dots&#10;&#10;Description automatically generated">
            <a:extLst>
              <a:ext uri="{FF2B5EF4-FFF2-40B4-BE49-F238E27FC236}">
                <a16:creationId xmlns:a16="http://schemas.microsoft.com/office/drawing/2014/main" id="{0E33E417-F979-2345-4C88-8AF614BDFC2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1269000"/>
            <a:ext cx="5760618" cy="4320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6AB5A99-8EB0-67DE-4E42-824873041328}"/>
              </a:ext>
            </a:extLst>
          </p:cNvPr>
          <p:cNvSpPr txBox="1"/>
          <p:nvPr/>
        </p:nvSpPr>
        <p:spPr>
          <a:xfrm>
            <a:off x="368622" y="1098471"/>
            <a:ext cx="4363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a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7D25DB5-AC72-55B7-00C1-3DBA6DE59172}"/>
              </a:ext>
            </a:extLst>
          </p:cNvPr>
          <p:cNvSpPr txBox="1"/>
          <p:nvPr/>
        </p:nvSpPr>
        <p:spPr>
          <a:xfrm>
            <a:off x="6118020" y="1098471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b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E99E83E-67E2-E4D7-281C-8CEE699D0724}"/>
              </a:ext>
            </a:extLst>
          </p:cNvPr>
          <p:cNvSpPr txBox="1"/>
          <p:nvPr/>
        </p:nvSpPr>
        <p:spPr>
          <a:xfrm>
            <a:off x="18558" y="0"/>
            <a:ext cx="609946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/>
              <a:t>SI Figure S3</a:t>
            </a:r>
          </a:p>
        </p:txBody>
      </p:sp>
    </p:spTree>
    <p:extLst>
      <p:ext uri="{BB962C8B-B14F-4D97-AF65-F5344CB8AC3E}">
        <p14:creationId xmlns:p14="http://schemas.microsoft.com/office/powerpoint/2010/main" val="8300550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06AB5A99-8EB0-67DE-4E42-824873041328}"/>
              </a:ext>
            </a:extLst>
          </p:cNvPr>
          <p:cNvSpPr txBox="1"/>
          <p:nvPr/>
        </p:nvSpPr>
        <p:spPr>
          <a:xfrm>
            <a:off x="368622" y="1098471"/>
            <a:ext cx="4363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a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7D25DB5-AC72-55B7-00C1-3DBA6DE59172}"/>
              </a:ext>
            </a:extLst>
          </p:cNvPr>
          <p:cNvSpPr txBox="1"/>
          <p:nvPr/>
        </p:nvSpPr>
        <p:spPr>
          <a:xfrm>
            <a:off x="6118020" y="1098471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b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E99E83E-67E2-E4D7-281C-8CEE699D0724}"/>
              </a:ext>
            </a:extLst>
          </p:cNvPr>
          <p:cNvSpPr txBox="1"/>
          <p:nvPr/>
        </p:nvSpPr>
        <p:spPr>
          <a:xfrm>
            <a:off x="18558" y="0"/>
            <a:ext cx="609946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/>
              <a:t>SI Figure S4</a:t>
            </a:r>
          </a:p>
        </p:txBody>
      </p:sp>
      <p:pic>
        <p:nvPicPr>
          <p:cNvPr id="2" name="Picture 1" descr="A diagram of a frequency spectrum&#10;&#10;Description automatically generated">
            <a:extLst>
              <a:ext uri="{FF2B5EF4-FFF2-40B4-BE49-F238E27FC236}">
                <a16:creationId xmlns:a16="http://schemas.microsoft.com/office/drawing/2014/main" id="{4F9B0154-F29F-7F48-06FF-125CAB0D662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18020" y="1467803"/>
            <a:ext cx="5760617" cy="4320000"/>
          </a:xfrm>
          <a:prstGeom prst="rect">
            <a:avLst/>
          </a:prstGeom>
        </p:spPr>
      </p:pic>
      <p:pic>
        <p:nvPicPr>
          <p:cNvPr id="7" name="Picture 6" descr="A diagram of a frequency spectrum&#10;&#10;Description automatically generated with medium confidence">
            <a:extLst>
              <a:ext uri="{FF2B5EF4-FFF2-40B4-BE49-F238E27FC236}">
                <a16:creationId xmlns:a16="http://schemas.microsoft.com/office/drawing/2014/main" id="{87A7AFC9-3B4F-1BBF-0586-59CEA94C4F8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7980" y="1467803"/>
            <a:ext cx="5760618" cy="43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763797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06AB5A99-8EB0-67DE-4E42-824873041328}"/>
              </a:ext>
            </a:extLst>
          </p:cNvPr>
          <p:cNvSpPr txBox="1"/>
          <p:nvPr/>
        </p:nvSpPr>
        <p:spPr>
          <a:xfrm>
            <a:off x="368622" y="1098471"/>
            <a:ext cx="4363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a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7D25DB5-AC72-55B7-00C1-3DBA6DE59172}"/>
              </a:ext>
            </a:extLst>
          </p:cNvPr>
          <p:cNvSpPr txBox="1"/>
          <p:nvPr/>
        </p:nvSpPr>
        <p:spPr>
          <a:xfrm>
            <a:off x="6118020" y="1098471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b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E99E83E-67E2-E4D7-281C-8CEE699D0724}"/>
              </a:ext>
            </a:extLst>
          </p:cNvPr>
          <p:cNvSpPr txBox="1"/>
          <p:nvPr/>
        </p:nvSpPr>
        <p:spPr>
          <a:xfrm>
            <a:off x="18558" y="0"/>
            <a:ext cx="609946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/>
              <a:t>SI Figure S</a:t>
            </a:r>
            <a:r>
              <a:rPr lang="en-US" b="1" dirty="0"/>
              <a:t>5</a:t>
            </a:r>
            <a:endParaRPr lang="en-US" sz="1800" b="1" dirty="0"/>
          </a:p>
        </p:txBody>
      </p:sp>
      <p:pic>
        <p:nvPicPr>
          <p:cNvPr id="2" name="Picture 1" descr="A diagram of a frequency spectrum&#10;&#10;Description automatically generated">
            <a:extLst>
              <a:ext uri="{FF2B5EF4-FFF2-40B4-BE49-F238E27FC236}">
                <a16:creationId xmlns:a16="http://schemas.microsoft.com/office/drawing/2014/main" id="{A824CC55-718D-E00A-7A7F-627C6A2BA7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9292" y="1439529"/>
            <a:ext cx="5760617" cy="4320000"/>
          </a:xfrm>
          <a:prstGeom prst="rect">
            <a:avLst/>
          </a:prstGeom>
        </p:spPr>
      </p:pic>
      <p:pic>
        <p:nvPicPr>
          <p:cNvPr id="7" name="Picture 6" descr="A diagram of a frequency spectrum&#10;&#10;Description automatically generated with medium confidence">
            <a:extLst>
              <a:ext uri="{FF2B5EF4-FFF2-40B4-BE49-F238E27FC236}">
                <a16:creationId xmlns:a16="http://schemas.microsoft.com/office/drawing/2014/main" id="{7DCC9603-8ADE-D65A-EE31-87D34BB7FF9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29909" y="1439529"/>
            <a:ext cx="5760617" cy="43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477645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82</TotalTime>
  <Words>60</Words>
  <Application>Microsoft Office PowerPoint</Application>
  <PresentationFormat>Widescreen</PresentationFormat>
  <Paragraphs>17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dema Figure</dc:title>
  <dc:creator>Chengyang Qian</dc:creator>
  <cp:lastModifiedBy>MDPI</cp:lastModifiedBy>
  <cp:revision>68</cp:revision>
  <dcterms:created xsi:type="dcterms:W3CDTF">2023-11-20T20:06:13Z</dcterms:created>
  <dcterms:modified xsi:type="dcterms:W3CDTF">2024-07-09T03:00:50Z</dcterms:modified>
</cp:coreProperties>
</file>